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04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2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561B1C-22EC-4C1B-B214-786496442C92}" type="datetimeFigureOut">
              <a:rPr lang="en-IE" smtClean="0"/>
              <a:t>23/11/2022</a:t>
            </a:fld>
            <a:endParaRPr lang="en-I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FB0621-0608-4DC1-B727-BE8B59647FD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6624530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lnSpc>
                <a:spcPct val="107000"/>
              </a:lnSpc>
              <a:spcAft>
                <a:spcPts val="800"/>
              </a:spcAft>
            </a:pPr>
            <a:endParaRPr lang="en-IE" sz="2400" b="1" dirty="0">
              <a:effectLst/>
              <a:highlight>
                <a:srgbClr val="FFFF00"/>
              </a:highlight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IE" sz="2400" b="1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e1. Flow chart for outcome analysis for LUNG-SAFE study. AKI=acute kidney injury; CKD=chronic kidney disease; MV=mechanical ventilation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2AE75C-CC5C-46B8-9AED-5BC368611F22}" type="slidenum">
              <a:rPr lang="en-IE" smtClean="0"/>
              <a:t>2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24506619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lnSpc>
                <a:spcPct val="107000"/>
              </a:lnSpc>
              <a:spcAft>
                <a:spcPts val="800"/>
              </a:spcAft>
            </a:pPr>
            <a:endParaRPr lang="en-IE" sz="1200" b="1" dirty="0" smtClean="0">
              <a:effectLst/>
              <a:highlight>
                <a:srgbClr val="FFFF00"/>
              </a:highlight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IE" sz="1200" b="1" dirty="0" smtClean="0"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e2. Flow chart for outcome analysis including chronic kidney disease</a:t>
            </a:r>
            <a:r>
              <a:rPr lang="en-IE" sz="1200" b="1" baseline="0" dirty="0" smtClean="0"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CKD)</a:t>
            </a:r>
            <a:r>
              <a:rPr lang="en-IE" sz="1200" b="1" dirty="0" smtClean="0"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AKI=acute kidney injury; CKD=chronic kidney disease; MV=mechanical ventilation.</a:t>
            </a:r>
          </a:p>
          <a:p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72AE75C-CC5C-46B8-9AED-5BC368611F22}" type="slidenum">
              <a:rPr lang="en-IE" smtClean="0"/>
              <a:t>3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86873367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E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e3: Kaplan Meier plot of 28-day hospital survival and AKI stage (including CKD)</a:t>
            </a:r>
          </a:p>
          <a:p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2AE75C-CC5C-46B8-9AED-5BC368611F22}" type="slidenum">
              <a:rPr lang="en-IE" smtClean="0"/>
              <a:t>4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25281298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E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e4: Kaplan Meier plot of 90-day hospital survival and AKI stage (including CKD)</a:t>
            </a:r>
          </a:p>
          <a:p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2AE75C-CC5C-46B8-9AED-5BC368611F22}" type="slidenum">
              <a:rPr lang="en-IE" smtClean="0"/>
              <a:t>5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01735004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E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e5. Hazard ratio plots for 28-day ICU mortality against AKI stage (including CKD patients)</a:t>
            </a:r>
          </a:p>
          <a:p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2AE75C-CC5C-46B8-9AED-5BC368611F22}" type="slidenum">
              <a:rPr lang="en-IE" smtClean="0"/>
              <a:t>6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36818720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E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e6. Hazard ratio plots for 90-day hospital mortality against AKI stage (including</a:t>
            </a:r>
            <a:r>
              <a:rPr lang="en-IE" sz="1800" baseline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KD patients</a:t>
            </a:r>
            <a:r>
              <a:rPr lang="en-IE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</a:p>
          <a:p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2AE75C-CC5C-46B8-9AED-5BC368611F22}" type="slidenum">
              <a:rPr lang="en-IE" smtClean="0"/>
              <a:t>7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57984889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E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e7: Number of missing observations per variable included in</a:t>
            </a:r>
            <a:r>
              <a:rPr lang="en-IE" sz="1200" baseline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alysis</a:t>
            </a:r>
            <a:endParaRPr lang="en-I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2AE75C-CC5C-46B8-9AED-5BC368611F22}" type="slidenum">
              <a:rPr lang="en-IE" smtClean="0"/>
              <a:t>8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61495829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E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e8. Hazard ratio plots for 28-day ICU mortality against AKI stage (using geographic region)</a:t>
            </a:r>
          </a:p>
          <a:p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2AE75C-CC5C-46B8-9AED-5BC368611F22}" type="slidenum">
              <a:rPr lang="en-IE" smtClean="0"/>
              <a:t>9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76941058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E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e9. Hazard ratio plots for 90-day hospital mortality against AKI stage (using geographic region)</a:t>
            </a:r>
          </a:p>
          <a:p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2AE75C-CC5C-46B8-9AED-5BC368611F22}" type="slidenum">
              <a:rPr lang="en-IE" smtClean="0"/>
              <a:t>10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3386355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E6648-9190-489B-A8AF-6F12A8E556E7}" type="datetimeFigureOut">
              <a:rPr lang="en-IE" smtClean="0"/>
              <a:t>23/11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D9733-3ED1-4BF9-A302-8AB78750594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3813805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E6648-9190-489B-A8AF-6F12A8E556E7}" type="datetimeFigureOut">
              <a:rPr lang="en-IE" smtClean="0"/>
              <a:t>23/11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D9733-3ED1-4BF9-A302-8AB78750594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125167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E6648-9190-489B-A8AF-6F12A8E556E7}" type="datetimeFigureOut">
              <a:rPr lang="en-IE" smtClean="0"/>
              <a:t>23/11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D9733-3ED1-4BF9-A302-8AB78750594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276927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E6648-9190-489B-A8AF-6F12A8E556E7}" type="datetimeFigureOut">
              <a:rPr lang="en-IE" smtClean="0"/>
              <a:t>23/11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D9733-3ED1-4BF9-A302-8AB78750594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2296518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E6648-9190-489B-A8AF-6F12A8E556E7}" type="datetimeFigureOut">
              <a:rPr lang="en-IE" smtClean="0"/>
              <a:t>23/11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D9733-3ED1-4BF9-A302-8AB78750594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76142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E6648-9190-489B-A8AF-6F12A8E556E7}" type="datetimeFigureOut">
              <a:rPr lang="en-IE" smtClean="0"/>
              <a:t>23/11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D9733-3ED1-4BF9-A302-8AB78750594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422940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E6648-9190-489B-A8AF-6F12A8E556E7}" type="datetimeFigureOut">
              <a:rPr lang="en-IE" smtClean="0"/>
              <a:t>23/11/2022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D9733-3ED1-4BF9-A302-8AB78750594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831098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E6648-9190-489B-A8AF-6F12A8E556E7}" type="datetimeFigureOut">
              <a:rPr lang="en-IE" smtClean="0"/>
              <a:t>23/11/2022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D9733-3ED1-4BF9-A302-8AB78750594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093668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E6648-9190-489B-A8AF-6F12A8E556E7}" type="datetimeFigureOut">
              <a:rPr lang="en-IE" smtClean="0"/>
              <a:t>23/11/2022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D9733-3ED1-4BF9-A302-8AB78750594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782094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E6648-9190-489B-A8AF-6F12A8E556E7}" type="datetimeFigureOut">
              <a:rPr lang="en-IE" smtClean="0"/>
              <a:t>23/11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D9733-3ED1-4BF9-A302-8AB78750594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274542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E6648-9190-489B-A8AF-6F12A8E556E7}" type="datetimeFigureOut">
              <a:rPr lang="en-IE" smtClean="0"/>
              <a:t>23/11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D9733-3ED1-4BF9-A302-8AB78750594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077448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AE6648-9190-489B-A8AF-6F12A8E556E7}" type="datetimeFigureOut">
              <a:rPr lang="en-IE" smtClean="0"/>
              <a:t>23/11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9D9733-3ED1-4BF9-A302-8AB78750594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8150889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5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IE" dirty="0" smtClean="0"/>
              <a:t>Supplementary figures E1-E9</a:t>
            </a:r>
            <a:endParaRPr lang="en-IE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61147284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3">
            <a:extLst>
              <a:ext uri="{FF2B5EF4-FFF2-40B4-BE49-F238E27FC236}">
                <a16:creationId xmlns:a16="http://schemas.microsoft.com/office/drawing/2014/main" id="{5EC6CFAD-AC06-4997-882A-F461AFA2DC49}"/>
              </a:ext>
            </a:extLst>
          </p:cNvPr>
          <p:cNvSpPr txBox="1">
            <a:spLocks/>
          </p:cNvSpPr>
          <p:nvPr/>
        </p:nvSpPr>
        <p:spPr>
          <a:xfrm>
            <a:off x="228600" y="153460"/>
            <a:ext cx="2206146" cy="7609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IE" dirty="0"/>
              <a:t>Figure e9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5593" y="1142995"/>
            <a:ext cx="6400813" cy="457200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5689" y="1142995"/>
            <a:ext cx="3329422" cy="3008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99577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FA7FFA57-B7C6-48DB-877B-0C4AB85E4E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8600" y="153460"/>
            <a:ext cx="2167467" cy="760942"/>
          </a:xfrm>
        </p:spPr>
        <p:txBody>
          <a:bodyPr>
            <a:normAutofit fontScale="90000"/>
          </a:bodyPr>
          <a:lstStyle/>
          <a:p>
            <a:r>
              <a:rPr lang="en-IE" dirty="0"/>
              <a:t>Figure e1 </a:t>
            </a:r>
          </a:p>
        </p:txBody>
      </p:sp>
      <p:grpSp>
        <p:nvGrpSpPr>
          <p:cNvPr id="52" name="Group 51"/>
          <p:cNvGrpSpPr/>
          <p:nvPr/>
        </p:nvGrpSpPr>
        <p:grpSpPr>
          <a:xfrm>
            <a:off x="951971" y="534674"/>
            <a:ext cx="9398231" cy="4340760"/>
            <a:chOff x="951971" y="534674"/>
            <a:chExt cx="9398231" cy="4340760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CB9F1391-A617-4833-93AF-D9D8FF6CD90E}"/>
                </a:ext>
              </a:extLst>
            </p:cNvPr>
            <p:cNvGrpSpPr/>
            <p:nvPr/>
          </p:nvGrpSpPr>
          <p:grpSpPr>
            <a:xfrm>
              <a:off x="951971" y="534674"/>
              <a:ext cx="9398231" cy="4340760"/>
              <a:chOff x="-1094616" y="0"/>
              <a:chExt cx="5995546" cy="3322212"/>
            </a:xfrm>
          </p:grpSpPr>
          <p:sp>
            <p:nvSpPr>
              <p:cNvPr id="8" name="Text Box 5">
                <a:extLst>
                  <a:ext uri="{FF2B5EF4-FFF2-40B4-BE49-F238E27FC236}">
                    <a16:creationId xmlns:a16="http://schemas.microsoft.com/office/drawing/2014/main" id="{D0564C75-BD41-4430-8058-24FE4288C72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8575" y="2284691"/>
                <a:ext cx="2195830" cy="304800"/>
              </a:xfrm>
              <a:prstGeom prst="rect">
                <a:avLst/>
              </a:prstGeom>
              <a:noFill/>
              <a:ln w="9525" algn="in">
                <a:solidFill>
                  <a:schemeClr val="dk1">
                    <a:lumMod val="0"/>
                    <a:lumOff val="0"/>
                  </a:schemeClr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  <p:txBody>
              <a:bodyPr rot="0" vert="horz" wrap="square" lIns="36576" tIns="36576" rIns="36576" bIns="36576" anchor="t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1,957</a:t>
                </a: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patients with outcome</a:t>
                </a:r>
              </a:p>
            </p:txBody>
          </p: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E6337A5D-9953-47FE-8C80-A74E325665F3}"/>
                  </a:ext>
                </a:extLst>
              </p:cNvPr>
              <p:cNvGrpSpPr/>
              <p:nvPr/>
            </p:nvGrpSpPr>
            <p:grpSpPr>
              <a:xfrm>
                <a:off x="-1094616" y="0"/>
                <a:ext cx="5995546" cy="3322212"/>
                <a:chOff x="-1094616" y="0"/>
                <a:chExt cx="5995546" cy="3322212"/>
              </a:xfrm>
            </p:grpSpPr>
            <p:sp>
              <p:nvSpPr>
                <p:cNvPr id="10" name="Text Box 3">
                  <a:extLst>
                    <a:ext uri="{FF2B5EF4-FFF2-40B4-BE49-F238E27FC236}">
                      <a16:creationId xmlns:a16="http://schemas.microsoft.com/office/drawing/2014/main" id="{964C8266-CF02-4570-BA7B-B5C9009E5B7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0" y="0"/>
                  <a:ext cx="2196131" cy="314325"/>
                </a:xfrm>
                <a:prstGeom prst="rect">
                  <a:avLst/>
                </a:prstGeom>
                <a:noFill/>
                <a:ln w="9525" algn="in">
                  <a:solidFill>
                    <a:schemeClr val="dk1">
                      <a:lumMod val="0"/>
                      <a:lumOff val="0"/>
                    </a:schemeClr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CCCCCC"/>
                        </a:outerShdw>
                      </a:effectLst>
                    </a14:hiddenEffects>
                  </a:ext>
                </a:extLst>
              </p:spPr>
              <p:txBody>
                <a:bodyPr rot="0" vert="horz" wrap="square" lIns="36576" tIns="36576" rIns="36576" bIns="36576" anchor="t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IE" sz="1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12,906</a:t>
                  </a:r>
                  <a:r>
                    <a:rPr lang="en-IE" sz="1600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 patients</a:t>
                  </a:r>
                </a:p>
              </p:txBody>
            </p:sp>
            <p:sp>
              <p:nvSpPr>
                <p:cNvPr id="11" name="Text Box 4">
                  <a:extLst>
                    <a:ext uri="{FF2B5EF4-FFF2-40B4-BE49-F238E27FC236}">
                      <a16:creationId xmlns:a16="http://schemas.microsoft.com/office/drawing/2014/main" id="{2FD94EA3-2070-4E0B-AD68-E0655F1952F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9050" y="590550"/>
                  <a:ext cx="2195830" cy="295275"/>
                </a:xfrm>
                <a:prstGeom prst="rect">
                  <a:avLst/>
                </a:prstGeom>
                <a:noFill/>
                <a:ln w="9525" algn="in">
                  <a:solidFill>
                    <a:schemeClr val="dk1">
                      <a:lumMod val="0"/>
                      <a:lumOff val="0"/>
                    </a:schemeClr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CCCCCC"/>
                        </a:outerShdw>
                      </a:effectLst>
                    </a14:hiddenEffects>
                  </a:ext>
                </a:extLst>
              </p:spPr>
              <p:txBody>
                <a:bodyPr rot="0" vert="horz" wrap="square" lIns="36576" tIns="36576" rIns="36576" bIns="36576" anchor="t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IE" sz="1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4,499 </a:t>
                  </a:r>
                  <a:r>
                    <a:rPr lang="en-IE" sz="1600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patients with AHRF</a:t>
                  </a:r>
                </a:p>
              </p:txBody>
            </p:sp>
            <p:sp>
              <p:nvSpPr>
                <p:cNvPr id="12" name="Text Box 5">
                  <a:extLst>
                    <a:ext uri="{FF2B5EF4-FFF2-40B4-BE49-F238E27FC236}">
                      <a16:creationId xmlns:a16="http://schemas.microsoft.com/office/drawing/2014/main" id="{6F4BF649-D50D-4A54-A46E-4756C3E238A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9050" y="1792541"/>
                  <a:ext cx="2195830" cy="304800"/>
                </a:xfrm>
                <a:prstGeom prst="rect">
                  <a:avLst/>
                </a:prstGeom>
                <a:noFill/>
                <a:ln w="9525" algn="in">
                  <a:solidFill>
                    <a:schemeClr val="dk1">
                      <a:lumMod val="0"/>
                      <a:lumOff val="0"/>
                    </a:schemeClr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CCCCCC"/>
                        </a:outerShdw>
                      </a:effectLst>
                    </a14:hiddenEffects>
                  </a:ext>
                </a:extLst>
              </p:spPr>
              <p:txBody>
                <a:bodyPr rot="0" vert="horz" wrap="square" lIns="36576" tIns="36576" rIns="36576" bIns="36576" anchor="t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IE" sz="1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2,377 </a:t>
                  </a:r>
                  <a:r>
                    <a:rPr lang="en-IE" sz="1600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 patients undergoing IMV </a:t>
                  </a:r>
                </a:p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IE" sz="1600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 </a:t>
                  </a:r>
                </a:p>
              </p:txBody>
            </p:sp>
            <p:cxnSp>
              <p:nvCxnSpPr>
                <p:cNvPr id="13" name="Line 7">
                  <a:extLst>
                    <a:ext uri="{FF2B5EF4-FFF2-40B4-BE49-F238E27FC236}">
                      <a16:creationId xmlns:a16="http://schemas.microsoft.com/office/drawing/2014/main" id="{853F5B70-C68F-4DC8-B3B2-620114771DF1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076325" y="304800"/>
                  <a:ext cx="0" cy="242570"/>
                </a:xfrm>
                <a:prstGeom prst="line">
                  <a:avLst/>
                </a:prstGeom>
                <a:noFill/>
                <a:ln w="9525">
                  <a:solidFill>
                    <a:schemeClr val="dk1">
                      <a:lumMod val="0"/>
                      <a:lumOff val="0"/>
                    </a:schemeClr>
                  </a:solidFill>
                  <a:round/>
                  <a:headEnd/>
                  <a:tailEnd type="triangl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CCCCCC"/>
                        </a:outerShdw>
                      </a:effectLst>
                    </a14:hiddenEffects>
                  </a:ext>
                </a:extLst>
              </p:spPr>
            </p:cxnSp>
            <p:cxnSp>
              <p:nvCxnSpPr>
                <p:cNvPr id="14" name="Line 8">
                  <a:extLst>
                    <a:ext uri="{FF2B5EF4-FFF2-40B4-BE49-F238E27FC236}">
                      <a16:creationId xmlns:a16="http://schemas.microsoft.com/office/drawing/2014/main" id="{A4F25C29-4546-4D7F-B9EA-BE0A578DF5A8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076325" y="1485900"/>
                  <a:ext cx="0" cy="304800"/>
                </a:xfrm>
                <a:prstGeom prst="line">
                  <a:avLst/>
                </a:prstGeom>
                <a:noFill/>
                <a:ln w="9525">
                  <a:solidFill>
                    <a:schemeClr val="dk1">
                      <a:lumMod val="0"/>
                      <a:lumOff val="0"/>
                    </a:schemeClr>
                  </a:solidFill>
                  <a:round/>
                  <a:headEnd/>
                  <a:tailEnd type="triangl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CCCCCC"/>
                        </a:outerShdw>
                      </a:effectLst>
                    </a14:hiddenEffects>
                  </a:ext>
                </a:extLst>
              </p:spPr>
            </p:cxnSp>
            <p:sp>
              <p:nvSpPr>
                <p:cNvPr id="20" name="Text Box 4">
                  <a:extLst>
                    <a:ext uri="{FF2B5EF4-FFF2-40B4-BE49-F238E27FC236}">
                      <a16:creationId xmlns:a16="http://schemas.microsoft.com/office/drawing/2014/main" id="{29647644-4952-459A-AE17-27A7FAA5A5F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-173355" y="1162050"/>
                  <a:ext cx="2475571" cy="295275"/>
                </a:xfrm>
                <a:prstGeom prst="rect">
                  <a:avLst/>
                </a:prstGeom>
                <a:noFill/>
                <a:ln w="9525" algn="in">
                  <a:solidFill>
                    <a:schemeClr val="dk1">
                      <a:lumMod val="0"/>
                      <a:lumOff val="0"/>
                    </a:schemeClr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CCCCCC"/>
                        </a:outerShdw>
                      </a:effectLst>
                    </a14:hiddenEffects>
                  </a:ext>
                </a:extLst>
              </p:spPr>
              <p:txBody>
                <a:bodyPr rot="0" vert="horz" wrap="square" lIns="36576" tIns="36576" rIns="36576" bIns="36576" anchor="t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IE" sz="1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2,813</a:t>
                  </a:r>
                  <a:r>
                    <a:rPr lang="en-IE" sz="1600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 patients with ARDS within 48 hours</a:t>
                  </a:r>
                </a:p>
              </p:txBody>
            </p:sp>
            <p:cxnSp>
              <p:nvCxnSpPr>
                <p:cNvPr id="21" name="Line 7">
                  <a:extLst>
                    <a:ext uri="{FF2B5EF4-FFF2-40B4-BE49-F238E27FC236}">
                      <a16:creationId xmlns:a16="http://schemas.microsoft.com/office/drawing/2014/main" id="{E04E8C98-9EF8-44A2-91AE-E45781210A78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085850" y="876300"/>
                  <a:ext cx="0" cy="242570"/>
                </a:xfrm>
                <a:prstGeom prst="line">
                  <a:avLst/>
                </a:prstGeom>
                <a:noFill/>
                <a:ln w="9525">
                  <a:solidFill>
                    <a:schemeClr val="dk1">
                      <a:lumMod val="0"/>
                      <a:lumOff val="0"/>
                    </a:schemeClr>
                  </a:solidFill>
                  <a:round/>
                  <a:headEnd/>
                  <a:tailEnd type="triangl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CCCCCC"/>
                        </a:outerShdw>
                      </a:effectLst>
                    </a14:hiddenEffects>
                  </a:ext>
                </a:extLst>
              </p:spPr>
            </p:cxnSp>
            <p:cxnSp>
              <p:nvCxnSpPr>
                <p:cNvPr id="24" name="Line 11">
                  <a:extLst>
                    <a:ext uri="{FF2B5EF4-FFF2-40B4-BE49-F238E27FC236}">
                      <a16:creationId xmlns:a16="http://schemas.microsoft.com/office/drawing/2014/main" id="{587686AB-F77B-4FFC-B194-D15519AAA89B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1085850" y="2204394"/>
                  <a:ext cx="1601470" cy="0"/>
                </a:xfrm>
                <a:prstGeom prst="line">
                  <a:avLst/>
                </a:prstGeom>
                <a:noFill/>
                <a:ln w="9525">
                  <a:solidFill>
                    <a:schemeClr val="dk1">
                      <a:lumMod val="0"/>
                      <a:lumOff val="0"/>
                    </a:schemeClr>
                  </a:solidFill>
                  <a:round/>
                  <a:headEnd/>
                  <a:tailEnd type="triangl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CCCCCC"/>
                        </a:outerShdw>
                      </a:effectLst>
                    </a14:hiddenEffects>
                  </a:ext>
                </a:extLst>
              </p:spPr>
            </p:cxnSp>
            <p:sp>
              <p:nvSpPr>
                <p:cNvPr id="25" name="Text Box 17">
                  <a:extLst>
                    <a:ext uri="{FF2B5EF4-FFF2-40B4-BE49-F238E27FC236}">
                      <a16:creationId xmlns:a16="http://schemas.microsoft.com/office/drawing/2014/main" id="{95B7235A-4236-465E-8D2C-BE098694767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705100" y="1756081"/>
                  <a:ext cx="2195830" cy="788874"/>
                </a:xfrm>
                <a:prstGeom prst="rect">
                  <a:avLst/>
                </a:prstGeom>
                <a:noFill/>
                <a:ln w="9525" algn="in">
                  <a:solidFill>
                    <a:schemeClr val="dk1">
                      <a:lumMod val="0"/>
                      <a:lumOff val="0"/>
                    </a:schemeClr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CCCCCC"/>
                        </a:outerShdw>
                      </a:effectLst>
                    </a14:hiddenEffects>
                  </a:ext>
                </a:extLst>
              </p:spPr>
              <p:txBody>
                <a:bodyPr rot="0" vert="horz" wrap="square" lIns="36576" tIns="36576" rIns="36576" bIns="36576" anchor="t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IE" sz="1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CKD n=244</a:t>
                  </a:r>
                </a:p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IE" sz="1600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Transfer from other ICU n=149</a:t>
                  </a:r>
                </a:p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IE" sz="1600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Missing creatinine data n=59</a:t>
                  </a:r>
                  <a:endPara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Text Box 5">
                  <a:extLst>
                    <a:ext uri="{FF2B5EF4-FFF2-40B4-BE49-F238E27FC236}">
                      <a16:creationId xmlns:a16="http://schemas.microsoft.com/office/drawing/2014/main" id="{FB315FDC-5B80-4758-B764-6877AAB1FD4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-1094616" y="3016043"/>
                  <a:ext cx="1382720" cy="306169"/>
                </a:xfrm>
                <a:prstGeom prst="rect">
                  <a:avLst/>
                </a:prstGeom>
                <a:noFill/>
                <a:ln w="9525" algn="in">
                  <a:solidFill>
                    <a:schemeClr val="dk1">
                      <a:lumMod val="0"/>
                      <a:lumOff val="0"/>
                    </a:schemeClr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CCCCCC"/>
                        </a:outerShdw>
                      </a:effectLst>
                    </a14:hiddenEffects>
                  </a:ext>
                </a:extLst>
              </p:spPr>
              <p:txBody>
                <a:bodyPr rot="0" vert="horz" wrap="square" lIns="36576" tIns="36576" rIns="36576" bIns="36576" anchor="t" anchorCtr="0" upright="1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IE" sz="1600" dirty="0">
                      <a:solidFill>
                        <a:srgbClr val="FF0000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No AKI n=1084</a:t>
                  </a:r>
                  <a:endParaRPr lang="en-IE" sz="1600" dirty="0">
                    <a:solidFill>
                      <a:srgbClr val="FF0000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cxnSp>
          <p:nvCxnSpPr>
            <p:cNvPr id="42" name="Line 8">
              <a:extLst>
                <a:ext uri="{FF2B5EF4-FFF2-40B4-BE49-F238E27FC236}">
                  <a16:creationId xmlns:a16="http://schemas.microsoft.com/office/drawing/2014/main" id="{C4C403B6-D957-4A89-9B63-C29F84B38D0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4347968" y="3946240"/>
              <a:ext cx="3510" cy="258681"/>
            </a:xfrm>
            <a:prstGeom prst="line">
              <a:avLst/>
            </a:prstGeom>
            <a:noFill/>
            <a:ln w="9525">
              <a:solidFill>
                <a:schemeClr val="dk1">
                  <a:lumMod val="0"/>
                  <a:lumOff val="0"/>
                </a:schemeClr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43" name="Line 8">
              <a:extLst>
                <a:ext uri="{FF2B5EF4-FFF2-40B4-BE49-F238E27FC236}">
                  <a16:creationId xmlns:a16="http://schemas.microsoft.com/office/drawing/2014/main" id="{C4C403B6-D957-4A89-9B63-C29F84B38D0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4351478" y="3280020"/>
              <a:ext cx="3510" cy="258681"/>
            </a:xfrm>
            <a:prstGeom prst="line">
              <a:avLst/>
            </a:prstGeom>
            <a:noFill/>
            <a:ln w="9525">
              <a:solidFill>
                <a:schemeClr val="dk1">
                  <a:lumMod val="0"/>
                  <a:lumOff val="0"/>
                </a:schemeClr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sp>
          <p:nvSpPr>
            <p:cNvPr id="39" name="Text Box 5">
              <a:extLst>
                <a:ext uri="{FF2B5EF4-FFF2-40B4-BE49-F238E27FC236}">
                  <a16:creationId xmlns:a16="http://schemas.microsoft.com/office/drawing/2014/main" id="{FB315FDC-5B80-4758-B764-6877AAB1FD4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914572" y="4475395"/>
              <a:ext cx="2167466" cy="400036"/>
            </a:xfrm>
            <a:prstGeom prst="rect">
              <a:avLst/>
            </a:prstGeom>
            <a:noFill/>
            <a:ln w="9525" algn="in">
              <a:solidFill>
                <a:schemeClr val="dk1">
                  <a:lumMod val="0"/>
                  <a:lumOff val="0"/>
                </a:schemeClr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rot="0" vert="horz" wrap="square" lIns="36576" tIns="36576" rIns="36576" bIns="36576" anchor="t" anchorCtr="0" upright="1"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IE" sz="1600" dirty="0">
                  <a:solidFill>
                    <a:srgbClr val="FF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tage 3 AKI n=360</a:t>
              </a:r>
            </a:p>
          </p:txBody>
        </p:sp>
        <p:sp>
          <p:nvSpPr>
            <p:cNvPr id="40" name="Text Box 5">
              <a:extLst>
                <a:ext uri="{FF2B5EF4-FFF2-40B4-BE49-F238E27FC236}">
                  <a16:creationId xmlns:a16="http://schemas.microsoft.com/office/drawing/2014/main" id="{FB315FDC-5B80-4758-B764-6877AAB1FD4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87930" y="4475395"/>
              <a:ext cx="2167466" cy="400036"/>
            </a:xfrm>
            <a:prstGeom prst="rect">
              <a:avLst/>
            </a:prstGeom>
            <a:noFill/>
            <a:ln w="9525" algn="in">
              <a:solidFill>
                <a:schemeClr val="dk1">
                  <a:lumMod val="0"/>
                  <a:lumOff val="0"/>
                </a:schemeClr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rot="0" vert="horz" wrap="square" lIns="36576" tIns="36576" rIns="36576" bIns="36576" anchor="t" anchorCtr="0" upright="1"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IE" sz="1600" dirty="0">
                  <a:solidFill>
                    <a:srgbClr val="FF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tage 2 AKI n=194</a:t>
              </a:r>
            </a:p>
          </p:txBody>
        </p:sp>
        <p:sp>
          <p:nvSpPr>
            <p:cNvPr id="41" name="Text Box 5">
              <a:extLst>
                <a:ext uri="{FF2B5EF4-FFF2-40B4-BE49-F238E27FC236}">
                  <a16:creationId xmlns:a16="http://schemas.microsoft.com/office/drawing/2014/main" id="{FB315FDC-5B80-4758-B764-6877AAB1FD4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68044" y="4465621"/>
              <a:ext cx="2167466" cy="400036"/>
            </a:xfrm>
            <a:prstGeom prst="rect">
              <a:avLst/>
            </a:prstGeom>
            <a:noFill/>
            <a:ln w="9525" algn="in">
              <a:solidFill>
                <a:schemeClr val="dk1">
                  <a:lumMod val="0"/>
                  <a:lumOff val="0"/>
                </a:schemeClr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rot="0" vert="horz" wrap="square" lIns="36576" tIns="36576" rIns="36576" bIns="36576" anchor="t" anchorCtr="0" upright="1"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IE" sz="1600" dirty="0">
                  <a:solidFill>
                    <a:srgbClr val="FF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tage 1 AKI n=319</a:t>
              </a:r>
            </a:p>
          </p:txBody>
        </p:sp>
        <p:cxnSp>
          <p:nvCxnSpPr>
            <p:cNvPr id="3" name="Straight Connector 2"/>
            <p:cNvCxnSpPr/>
            <p:nvPr/>
          </p:nvCxnSpPr>
          <p:spPr>
            <a:xfrm>
              <a:off x="2045955" y="4194428"/>
              <a:ext cx="6952350" cy="2931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Line 8">
              <a:extLst>
                <a:ext uri="{FF2B5EF4-FFF2-40B4-BE49-F238E27FC236}">
                  <a16:creationId xmlns:a16="http://schemas.microsoft.com/office/drawing/2014/main" id="{C4C403B6-D957-4A89-9B63-C29F84B38D0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045955" y="4194428"/>
              <a:ext cx="3510" cy="258681"/>
            </a:xfrm>
            <a:prstGeom prst="line">
              <a:avLst/>
            </a:prstGeom>
            <a:noFill/>
            <a:ln w="9525">
              <a:solidFill>
                <a:schemeClr val="dk1">
                  <a:lumMod val="0"/>
                  <a:lumOff val="0"/>
                </a:schemeClr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49" name="Line 8">
              <a:extLst>
                <a:ext uri="{FF2B5EF4-FFF2-40B4-BE49-F238E27FC236}">
                  <a16:creationId xmlns:a16="http://schemas.microsoft.com/office/drawing/2014/main" id="{C4C403B6-D957-4A89-9B63-C29F84B38D0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4352523" y="4210096"/>
              <a:ext cx="3510" cy="258681"/>
            </a:xfrm>
            <a:prstGeom prst="line">
              <a:avLst/>
            </a:prstGeom>
            <a:noFill/>
            <a:ln w="9525">
              <a:solidFill>
                <a:schemeClr val="dk1">
                  <a:lumMod val="0"/>
                  <a:lumOff val="0"/>
                </a:schemeClr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50" name="Line 8">
              <a:extLst>
                <a:ext uri="{FF2B5EF4-FFF2-40B4-BE49-F238E27FC236}">
                  <a16:creationId xmlns:a16="http://schemas.microsoft.com/office/drawing/2014/main" id="{C4C403B6-D957-4A89-9B63-C29F84B38D0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6645354" y="4223744"/>
              <a:ext cx="3510" cy="258681"/>
            </a:xfrm>
            <a:prstGeom prst="line">
              <a:avLst/>
            </a:prstGeom>
            <a:noFill/>
            <a:ln w="9525">
              <a:solidFill>
                <a:schemeClr val="dk1">
                  <a:lumMod val="0"/>
                  <a:lumOff val="0"/>
                </a:schemeClr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51" name="Line 8">
              <a:extLst>
                <a:ext uri="{FF2B5EF4-FFF2-40B4-BE49-F238E27FC236}">
                  <a16:creationId xmlns:a16="http://schemas.microsoft.com/office/drawing/2014/main" id="{C4C403B6-D957-4A89-9B63-C29F84B38D0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8998305" y="4223744"/>
              <a:ext cx="3510" cy="258681"/>
            </a:xfrm>
            <a:prstGeom prst="line">
              <a:avLst/>
            </a:prstGeom>
            <a:noFill/>
            <a:ln w="9525">
              <a:solidFill>
                <a:schemeClr val="dk1">
                  <a:lumMod val="0"/>
                  <a:lumOff val="0"/>
                </a:schemeClr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</p:grpSp>
    </p:spTree>
    <p:extLst>
      <p:ext uri="{BB962C8B-B14F-4D97-AF65-F5344CB8AC3E}">
        <p14:creationId xmlns:p14="http://schemas.microsoft.com/office/powerpoint/2010/main" val="19622053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3">
            <a:extLst>
              <a:ext uri="{FF2B5EF4-FFF2-40B4-BE49-F238E27FC236}">
                <a16:creationId xmlns:a16="http://schemas.microsoft.com/office/drawing/2014/main" id="{FA7FFA57-B7C6-48DB-877B-0C4AB85E4E58}"/>
              </a:ext>
            </a:extLst>
          </p:cNvPr>
          <p:cNvSpPr txBox="1">
            <a:spLocks/>
          </p:cNvSpPr>
          <p:nvPr/>
        </p:nvSpPr>
        <p:spPr>
          <a:xfrm>
            <a:off x="228600" y="153460"/>
            <a:ext cx="2167467" cy="7609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IE" dirty="0"/>
              <a:t>Figure e2 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CB9F1391-A617-4833-93AF-D9D8FF6CD90E}"/>
              </a:ext>
            </a:extLst>
          </p:cNvPr>
          <p:cNvGrpSpPr/>
          <p:nvPr/>
        </p:nvGrpSpPr>
        <p:grpSpPr>
          <a:xfrm>
            <a:off x="2667808" y="616267"/>
            <a:ext cx="7682394" cy="6035940"/>
            <a:chOff x="0" y="0"/>
            <a:chExt cx="4900930" cy="4619625"/>
          </a:xfrm>
        </p:grpSpPr>
        <p:sp>
          <p:nvSpPr>
            <p:cNvPr id="5" name="Text Box 5">
              <a:extLst>
                <a:ext uri="{FF2B5EF4-FFF2-40B4-BE49-F238E27FC236}">
                  <a16:creationId xmlns:a16="http://schemas.microsoft.com/office/drawing/2014/main" id="{D0564C75-BD41-4430-8058-24FE4288C72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575" y="2284691"/>
              <a:ext cx="2195830" cy="304800"/>
            </a:xfrm>
            <a:prstGeom prst="rect">
              <a:avLst/>
            </a:prstGeom>
            <a:noFill/>
            <a:ln w="9525" algn="in">
              <a:solidFill>
                <a:schemeClr val="dk1">
                  <a:lumMod val="0"/>
                  <a:lumOff val="0"/>
                </a:schemeClr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rot="0" vert="horz" wrap="square" lIns="36576" tIns="36576" rIns="36576" bIns="36576" anchor="t" anchorCtr="0" upright="1"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800"/>
                </a:spcAft>
              </a:pPr>
              <a:r>
                <a:rPr lang="en-IE" sz="16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5,159</a:t>
              </a:r>
              <a:r>
                <a:rPr lang="en-IE" sz="16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patients with outcome</a:t>
              </a:r>
            </a:p>
          </p:txBody>
        </p: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E6337A5D-9953-47FE-8C80-A74E325665F3}"/>
                </a:ext>
              </a:extLst>
            </p:cNvPr>
            <p:cNvGrpSpPr/>
            <p:nvPr/>
          </p:nvGrpSpPr>
          <p:grpSpPr>
            <a:xfrm>
              <a:off x="0" y="0"/>
              <a:ext cx="4900930" cy="4619625"/>
              <a:chOff x="0" y="0"/>
              <a:chExt cx="4900930" cy="4619625"/>
            </a:xfrm>
          </p:grpSpPr>
          <p:sp>
            <p:nvSpPr>
              <p:cNvPr id="7" name="Text Box 3">
                <a:extLst>
                  <a:ext uri="{FF2B5EF4-FFF2-40B4-BE49-F238E27FC236}">
                    <a16:creationId xmlns:a16="http://schemas.microsoft.com/office/drawing/2014/main" id="{964C8266-CF02-4570-BA7B-B5C9009E5B7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0" y="0"/>
                <a:ext cx="2196131" cy="314325"/>
              </a:xfrm>
              <a:prstGeom prst="rect">
                <a:avLst/>
              </a:prstGeom>
              <a:noFill/>
              <a:ln w="9525" algn="in">
                <a:solidFill>
                  <a:schemeClr val="dk1">
                    <a:lumMod val="0"/>
                    <a:lumOff val="0"/>
                  </a:schemeClr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  <p:txBody>
              <a:bodyPr rot="0" vert="horz" wrap="square" lIns="36576" tIns="36576" rIns="36576" bIns="36576" anchor="t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18,964</a:t>
                </a: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patients</a:t>
                </a:r>
              </a:p>
            </p:txBody>
          </p:sp>
          <p:sp>
            <p:nvSpPr>
              <p:cNvPr id="8" name="Text Box 4">
                <a:extLst>
                  <a:ext uri="{FF2B5EF4-FFF2-40B4-BE49-F238E27FC236}">
                    <a16:creationId xmlns:a16="http://schemas.microsoft.com/office/drawing/2014/main" id="{2FD94EA3-2070-4E0B-AD68-E0655F1952F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9050" y="590550"/>
                <a:ext cx="2195830" cy="295275"/>
              </a:xfrm>
              <a:prstGeom prst="rect">
                <a:avLst/>
              </a:prstGeom>
              <a:noFill/>
              <a:ln w="9525" algn="in">
                <a:solidFill>
                  <a:schemeClr val="dk1">
                    <a:lumMod val="0"/>
                    <a:lumOff val="0"/>
                  </a:schemeClr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  <p:txBody>
              <a:bodyPr rot="0" vert="horz" wrap="square" lIns="36576" tIns="36576" rIns="36576" bIns="36576" anchor="t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10,112</a:t>
                </a: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patients on MV</a:t>
                </a:r>
              </a:p>
            </p:txBody>
          </p:sp>
          <p:sp>
            <p:nvSpPr>
              <p:cNvPr id="9" name="Text Box 5">
                <a:extLst>
                  <a:ext uri="{FF2B5EF4-FFF2-40B4-BE49-F238E27FC236}">
                    <a16:creationId xmlns:a16="http://schemas.microsoft.com/office/drawing/2014/main" id="{6F4BF649-D50D-4A54-A46E-4756C3E238A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9050" y="1771650"/>
                <a:ext cx="2195830" cy="304800"/>
              </a:xfrm>
              <a:prstGeom prst="rect">
                <a:avLst/>
              </a:prstGeom>
              <a:noFill/>
              <a:ln w="9525" algn="in">
                <a:solidFill>
                  <a:schemeClr val="dk1">
                    <a:lumMod val="0"/>
                    <a:lumOff val="0"/>
                  </a:schemeClr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  <p:txBody>
              <a:bodyPr rot="0" vert="horz" wrap="square" lIns="36576" tIns="36576" rIns="36576" bIns="36576" anchor="t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7,873</a:t>
                </a: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patients first MV day available</a:t>
                </a:r>
              </a:p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 </a:t>
                </a:r>
              </a:p>
            </p:txBody>
          </p:sp>
          <p:cxnSp>
            <p:nvCxnSpPr>
              <p:cNvPr id="10" name="Line 7">
                <a:extLst>
                  <a:ext uri="{FF2B5EF4-FFF2-40B4-BE49-F238E27FC236}">
                    <a16:creationId xmlns:a16="http://schemas.microsoft.com/office/drawing/2014/main" id="{853F5B70-C68F-4DC8-B3B2-620114771DF1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076325" y="304800"/>
                <a:ext cx="0" cy="242570"/>
              </a:xfrm>
              <a:prstGeom prst="line">
                <a:avLst/>
              </a:prstGeom>
              <a:noFill/>
              <a:ln w="9525">
                <a:solidFill>
                  <a:schemeClr val="dk1">
                    <a:lumMod val="0"/>
                    <a:lumOff val="0"/>
                  </a:schemeClr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11" name="Line 8">
                <a:extLst>
                  <a:ext uri="{FF2B5EF4-FFF2-40B4-BE49-F238E27FC236}">
                    <a16:creationId xmlns:a16="http://schemas.microsoft.com/office/drawing/2014/main" id="{A4F25C29-4546-4D7F-B9EA-BE0A578DF5A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074086" y="885825"/>
                <a:ext cx="2239" cy="904875"/>
              </a:xfrm>
              <a:prstGeom prst="line">
                <a:avLst/>
              </a:prstGeom>
              <a:noFill/>
              <a:ln w="9525">
                <a:solidFill>
                  <a:schemeClr val="dk1">
                    <a:lumMod val="0"/>
                    <a:lumOff val="0"/>
                  </a:schemeClr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12" name="Line 10">
                <a:extLst>
                  <a:ext uri="{FF2B5EF4-FFF2-40B4-BE49-F238E27FC236}">
                    <a16:creationId xmlns:a16="http://schemas.microsoft.com/office/drawing/2014/main" id="{07498AD9-390D-4D5C-AE49-A1B250C687ED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076325" y="381000"/>
                <a:ext cx="1601470" cy="0"/>
              </a:xfrm>
              <a:prstGeom prst="line">
                <a:avLst/>
              </a:prstGeom>
              <a:noFill/>
              <a:ln w="9525">
                <a:solidFill>
                  <a:schemeClr val="dk1">
                    <a:lumMod val="0"/>
                    <a:lumOff val="0"/>
                  </a:schemeClr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13" name="Line 11">
                <a:extLst>
                  <a:ext uri="{FF2B5EF4-FFF2-40B4-BE49-F238E27FC236}">
                    <a16:creationId xmlns:a16="http://schemas.microsoft.com/office/drawing/2014/main" id="{6427F927-D7A3-4DD6-B937-4699E905F24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076325" y="1581150"/>
                <a:ext cx="1602096" cy="0"/>
              </a:xfrm>
              <a:prstGeom prst="line">
                <a:avLst/>
              </a:prstGeom>
              <a:noFill/>
              <a:ln w="9525">
                <a:solidFill>
                  <a:schemeClr val="dk1">
                    <a:lumMod val="0"/>
                    <a:lumOff val="0"/>
                  </a:schemeClr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</p:cxnSp>
          <p:sp>
            <p:nvSpPr>
              <p:cNvPr id="14" name="Text Box 17">
                <a:extLst>
                  <a:ext uri="{FF2B5EF4-FFF2-40B4-BE49-F238E27FC236}">
                    <a16:creationId xmlns:a16="http://schemas.microsoft.com/office/drawing/2014/main" id="{84227BA0-F95C-4194-93E1-205C9D255E9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686050" y="1476375"/>
                <a:ext cx="2195830" cy="295275"/>
              </a:xfrm>
              <a:prstGeom prst="rect">
                <a:avLst/>
              </a:prstGeom>
              <a:noFill/>
              <a:ln w="9525" algn="in">
                <a:solidFill>
                  <a:schemeClr val="dk1">
                    <a:lumMod val="0"/>
                    <a:lumOff val="0"/>
                  </a:schemeClr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  <p:txBody>
              <a:bodyPr rot="0" vert="horz" wrap="square" lIns="36576" tIns="36576" rIns="36576" bIns="36576" anchor="t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,239</a:t>
                </a: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transferred in on MV</a:t>
                </a:r>
              </a:p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 </a:t>
                </a:r>
              </a:p>
            </p:txBody>
          </p:sp>
          <p:sp>
            <p:nvSpPr>
              <p:cNvPr id="16" name="Text Box 18">
                <a:extLst>
                  <a:ext uri="{FF2B5EF4-FFF2-40B4-BE49-F238E27FC236}">
                    <a16:creationId xmlns:a16="http://schemas.microsoft.com/office/drawing/2014/main" id="{6B6E9F0F-B252-4D34-8861-050CF8D8F3F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05100" y="200025"/>
                <a:ext cx="2195830" cy="266700"/>
              </a:xfrm>
              <a:prstGeom prst="rect">
                <a:avLst/>
              </a:prstGeom>
              <a:noFill/>
              <a:ln w="9525" algn="in">
                <a:solidFill>
                  <a:schemeClr val="dk1">
                    <a:lumMod val="0"/>
                    <a:lumOff val="0"/>
                  </a:schemeClr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  <p:txBody>
              <a:bodyPr rot="0" vert="horz" wrap="square" lIns="36576" tIns="36576" rIns="36576" bIns="36576" anchor="t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8,852 not on MV</a:t>
                </a:r>
              </a:p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 </a:t>
                </a:r>
              </a:p>
            </p:txBody>
          </p:sp>
          <p:cxnSp>
            <p:nvCxnSpPr>
              <p:cNvPr id="20" name="Line 11">
                <a:extLst>
                  <a:ext uri="{FF2B5EF4-FFF2-40B4-BE49-F238E27FC236}">
                    <a16:creationId xmlns:a16="http://schemas.microsoft.com/office/drawing/2014/main" id="{587686AB-F77B-4FFC-B194-D15519AAA89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085850" y="2204394"/>
                <a:ext cx="1601470" cy="0"/>
              </a:xfrm>
              <a:prstGeom prst="line">
                <a:avLst/>
              </a:prstGeom>
              <a:noFill/>
              <a:ln w="9525">
                <a:solidFill>
                  <a:schemeClr val="dk1">
                    <a:lumMod val="0"/>
                    <a:lumOff val="0"/>
                  </a:schemeClr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</p:cxnSp>
          <p:sp>
            <p:nvSpPr>
              <p:cNvPr id="21" name="Text Box 17">
                <a:extLst>
                  <a:ext uri="{FF2B5EF4-FFF2-40B4-BE49-F238E27FC236}">
                    <a16:creationId xmlns:a16="http://schemas.microsoft.com/office/drawing/2014/main" id="{95B7235A-4236-465E-8D2C-BE098694767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695575" y="2066925"/>
                <a:ext cx="2195830" cy="295275"/>
              </a:xfrm>
              <a:prstGeom prst="rect">
                <a:avLst/>
              </a:prstGeom>
              <a:noFill/>
              <a:ln w="9525" algn="in">
                <a:solidFill>
                  <a:schemeClr val="dk1">
                    <a:lumMod val="0"/>
                    <a:lumOff val="0"/>
                  </a:schemeClr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  <p:txBody>
              <a:bodyPr rot="0" vert="horz" wrap="square" lIns="36576" tIns="36576" rIns="36576" bIns="36576" anchor="t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,714</a:t>
                </a: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missing outcome</a:t>
                </a:r>
              </a:p>
            </p:txBody>
          </p:sp>
          <p:sp>
            <p:nvSpPr>
              <p:cNvPr id="22" name="Text Box 5">
                <a:extLst>
                  <a:ext uri="{FF2B5EF4-FFF2-40B4-BE49-F238E27FC236}">
                    <a16:creationId xmlns:a16="http://schemas.microsoft.com/office/drawing/2014/main" id="{94EA6F1D-6A11-41A3-8D21-36E1C713DC8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8575" y="2769386"/>
                <a:ext cx="2195830" cy="295275"/>
              </a:xfrm>
              <a:prstGeom prst="rect">
                <a:avLst/>
              </a:prstGeom>
              <a:noFill/>
              <a:ln w="9525" algn="in">
                <a:solidFill>
                  <a:schemeClr val="dk1">
                    <a:lumMod val="0"/>
                    <a:lumOff val="0"/>
                  </a:schemeClr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  <p:txBody>
              <a:bodyPr rot="0" vert="horz" wrap="square" lIns="36576" tIns="36576" rIns="36576" bIns="36576" anchor="t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,647 </a:t>
                </a: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patients with outcome and date</a:t>
                </a:r>
              </a:p>
            </p:txBody>
          </p:sp>
          <p:cxnSp>
            <p:nvCxnSpPr>
              <p:cNvPr id="23" name="Line 11">
                <a:extLst>
                  <a:ext uri="{FF2B5EF4-FFF2-40B4-BE49-F238E27FC236}">
                    <a16:creationId xmlns:a16="http://schemas.microsoft.com/office/drawing/2014/main" id="{63C0E4CB-F714-463E-933F-68AF8EC8EB1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074086" y="2704420"/>
                <a:ext cx="1601470" cy="0"/>
              </a:xfrm>
              <a:prstGeom prst="line">
                <a:avLst/>
              </a:prstGeom>
              <a:noFill/>
              <a:ln w="9525">
                <a:solidFill>
                  <a:schemeClr val="dk1">
                    <a:lumMod val="0"/>
                    <a:lumOff val="0"/>
                  </a:schemeClr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</p:cxnSp>
          <p:sp>
            <p:nvSpPr>
              <p:cNvPr id="24" name="Text Box 17">
                <a:extLst>
                  <a:ext uri="{FF2B5EF4-FFF2-40B4-BE49-F238E27FC236}">
                    <a16:creationId xmlns:a16="http://schemas.microsoft.com/office/drawing/2014/main" id="{779216DD-4604-4B00-A1C6-F23D718A132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695575" y="2628900"/>
                <a:ext cx="2195830" cy="295275"/>
              </a:xfrm>
              <a:prstGeom prst="rect">
                <a:avLst/>
              </a:prstGeom>
              <a:noFill/>
              <a:ln w="9525" algn="in">
                <a:solidFill>
                  <a:schemeClr val="dk1">
                    <a:lumMod val="0"/>
                    <a:lumOff val="0"/>
                  </a:schemeClr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  <p:txBody>
              <a:bodyPr rot="0" vert="horz" wrap="square" lIns="36576" tIns="36576" rIns="36576" bIns="36576" anchor="t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,512</a:t>
                </a: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missing dates</a:t>
                </a:r>
              </a:p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 </a:t>
                </a:r>
              </a:p>
            </p:txBody>
          </p:sp>
          <p:sp>
            <p:nvSpPr>
              <p:cNvPr id="25" name="Text Box 5">
                <a:extLst>
                  <a:ext uri="{FF2B5EF4-FFF2-40B4-BE49-F238E27FC236}">
                    <a16:creationId xmlns:a16="http://schemas.microsoft.com/office/drawing/2014/main" id="{FB315FDC-5B80-4758-B764-6877AAB1FD4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6200" y="3817482"/>
                <a:ext cx="2195830" cy="295275"/>
              </a:xfrm>
              <a:prstGeom prst="rect">
                <a:avLst/>
              </a:prstGeom>
              <a:noFill/>
              <a:ln w="9525" algn="in">
                <a:solidFill>
                  <a:schemeClr val="dk1">
                    <a:lumMod val="0"/>
                    <a:lumOff val="0"/>
                  </a:schemeClr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  <p:txBody>
              <a:bodyPr rot="0" vert="horz" wrap="square" lIns="36576" tIns="36576" rIns="36576" bIns="36576" anchor="t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1,985 patients with AKI data</a:t>
                </a:r>
              </a:p>
            </p:txBody>
          </p:sp>
          <p:cxnSp>
            <p:nvCxnSpPr>
              <p:cNvPr id="26" name="Line 8">
                <a:extLst>
                  <a:ext uri="{FF2B5EF4-FFF2-40B4-BE49-F238E27FC236}">
                    <a16:creationId xmlns:a16="http://schemas.microsoft.com/office/drawing/2014/main" id="{C4C403B6-D957-4A89-9B63-C29F84B38D07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092074" y="3619500"/>
                <a:ext cx="2239" cy="197982"/>
              </a:xfrm>
              <a:prstGeom prst="line">
                <a:avLst/>
              </a:prstGeom>
              <a:noFill/>
              <a:ln w="9525">
                <a:solidFill>
                  <a:schemeClr val="dk1">
                    <a:lumMod val="0"/>
                    <a:lumOff val="0"/>
                  </a:schemeClr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27" name="Line 11">
                <a:extLst>
                  <a:ext uri="{FF2B5EF4-FFF2-40B4-BE49-F238E27FC236}">
                    <a16:creationId xmlns:a16="http://schemas.microsoft.com/office/drawing/2014/main" id="{F013BF98-5041-436D-BA7F-BE071E3C0380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094105" y="3681513"/>
                <a:ext cx="1601470" cy="0"/>
              </a:xfrm>
              <a:prstGeom prst="line">
                <a:avLst/>
              </a:prstGeom>
              <a:noFill/>
              <a:ln w="9525">
                <a:solidFill>
                  <a:schemeClr val="dk1">
                    <a:lumMod val="0"/>
                    <a:lumOff val="0"/>
                  </a:schemeClr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</p:cxnSp>
          <p:sp>
            <p:nvSpPr>
              <p:cNvPr id="28" name="Text Box 17">
                <a:extLst>
                  <a:ext uri="{FF2B5EF4-FFF2-40B4-BE49-F238E27FC236}">
                    <a16:creationId xmlns:a16="http://schemas.microsoft.com/office/drawing/2014/main" id="{D3E9DCD6-0E0E-4ED1-B56D-12AC10DB723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05100" y="3533775"/>
                <a:ext cx="2195830" cy="295275"/>
              </a:xfrm>
              <a:prstGeom prst="rect">
                <a:avLst/>
              </a:prstGeom>
              <a:noFill/>
              <a:ln w="9525" algn="in">
                <a:solidFill>
                  <a:schemeClr val="dk1">
                    <a:lumMod val="0"/>
                    <a:lumOff val="0"/>
                  </a:schemeClr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  <p:txBody>
              <a:bodyPr rot="0" vert="horz" wrap="square" lIns="36576" tIns="36576" rIns="36576" bIns="36576" anchor="t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7</a:t>
                </a: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missing AKI</a:t>
                </a:r>
                <a:r>
                  <a:rPr lang="en-IE" sz="1600" dirty="0">
                    <a:solidFill>
                      <a:srgbClr val="FF0000"/>
                    </a:solidFill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</a:t>
                </a: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data</a:t>
                </a:r>
              </a:p>
            </p:txBody>
          </p:sp>
          <p:sp>
            <p:nvSpPr>
              <p:cNvPr id="29" name="Text Box 5">
                <a:extLst>
                  <a:ext uri="{FF2B5EF4-FFF2-40B4-BE49-F238E27FC236}">
                    <a16:creationId xmlns:a16="http://schemas.microsoft.com/office/drawing/2014/main" id="{AA96426C-2EFE-4E96-A8D0-88F9E403789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6200" y="4324350"/>
                <a:ext cx="2195830" cy="295275"/>
              </a:xfrm>
              <a:prstGeom prst="rect">
                <a:avLst/>
              </a:prstGeom>
              <a:noFill/>
              <a:ln w="9525" algn="in">
                <a:solidFill>
                  <a:schemeClr val="dk1">
                    <a:lumMod val="0"/>
                    <a:lumOff val="0"/>
                  </a:schemeClr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  <p:txBody>
              <a:bodyPr rot="0" vert="horz" wrap="square" lIns="36576" tIns="36576" rIns="36576" bIns="36576" anchor="t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1,927 patients for analysis</a:t>
                </a:r>
              </a:p>
            </p:txBody>
          </p:sp>
          <p:cxnSp>
            <p:nvCxnSpPr>
              <p:cNvPr id="30" name="Line 8">
                <a:extLst>
                  <a:ext uri="{FF2B5EF4-FFF2-40B4-BE49-F238E27FC236}">
                    <a16:creationId xmlns:a16="http://schemas.microsoft.com/office/drawing/2014/main" id="{F84CE5A9-9EB3-4927-81E3-15FE91B26279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095375" y="4119728"/>
                <a:ext cx="0" cy="204622"/>
              </a:xfrm>
              <a:prstGeom prst="line">
                <a:avLst/>
              </a:prstGeom>
              <a:noFill/>
              <a:ln w="9525">
                <a:solidFill>
                  <a:schemeClr val="dk1">
                    <a:lumMod val="0"/>
                    <a:lumOff val="0"/>
                  </a:schemeClr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31" name="Line 11">
                <a:extLst>
                  <a:ext uri="{FF2B5EF4-FFF2-40B4-BE49-F238E27FC236}">
                    <a16:creationId xmlns:a16="http://schemas.microsoft.com/office/drawing/2014/main" id="{4761F688-3C7B-459C-B454-375437098A6C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104900" y="4244707"/>
                <a:ext cx="1601470" cy="0"/>
              </a:xfrm>
              <a:prstGeom prst="line">
                <a:avLst/>
              </a:prstGeom>
              <a:noFill/>
              <a:ln w="9525">
                <a:solidFill>
                  <a:schemeClr val="dk1">
                    <a:lumMod val="0"/>
                    <a:lumOff val="0"/>
                  </a:schemeClr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</p:cxnSp>
          <p:sp>
            <p:nvSpPr>
              <p:cNvPr id="32" name="Text Box 17">
                <a:extLst>
                  <a:ext uri="{FF2B5EF4-FFF2-40B4-BE49-F238E27FC236}">
                    <a16:creationId xmlns:a16="http://schemas.microsoft.com/office/drawing/2014/main" id="{AA1E5FAC-9DA9-45CA-B53C-CD5FA39706C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05100" y="4119728"/>
                <a:ext cx="2195830" cy="295275"/>
              </a:xfrm>
              <a:prstGeom prst="rect">
                <a:avLst/>
              </a:prstGeom>
              <a:noFill/>
              <a:ln w="9525" algn="in">
                <a:solidFill>
                  <a:schemeClr val="dk1">
                    <a:lumMod val="0"/>
                    <a:lumOff val="0"/>
                  </a:schemeClr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  <p:txBody>
              <a:bodyPr rot="0" vert="horz" wrap="square" lIns="36576" tIns="36576" rIns="36576" bIns="36576" anchor="t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58</a:t>
                </a: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with miscoded dates</a:t>
                </a:r>
              </a:p>
            </p:txBody>
          </p:sp>
          <p:sp>
            <p:nvSpPr>
              <p:cNvPr id="33" name="Text Box 5">
                <a:extLst>
                  <a:ext uri="{FF2B5EF4-FFF2-40B4-BE49-F238E27FC236}">
                    <a16:creationId xmlns:a16="http://schemas.microsoft.com/office/drawing/2014/main" id="{FB315FDC-5B80-4758-B764-6877AAB1FD4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8575" y="3276254"/>
                <a:ext cx="2195830" cy="295275"/>
              </a:xfrm>
              <a:prstGeom prst="rect">
                <a:avLst/>
              </a:prstGeom>
              <a:noFill/>
              <a:ln w="9525" algn="in">
                <a:solidFill>
                  <a:schemeClr val="dk1">
                    <a:lumMod val="0"/>
                    <a:lumOff val="0"/>
                  </a:schemeClr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  <p:txBody>
              <a:bodyPr rot="0" vert="horz" wrap="square" lIns="36576" tIns="36576" rIns="36576" bIns="36576" anchor="t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,012 patients with confirmed ARDS</a:t>
                </a:r>
              </a:p>
            </p:txBody>
          </p:sp>
          <p:cxnSp>
            <p:nvCxnSpPr>
              <p:cNvPr id="34" name="Line 11">
                <a:extLst>
                  <a:ext uri="{FF2B5EF4-FFF2-40B4-BE49-F238E27FC236}">
                    <a16:creationId xmlns:a16="http://schemas.microsoft.com/office/drawing/2014/main" id="{63C0E4CB-F714-463E-933F-68AF8EC8EB1B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1083612" y="3142736"/>
                <a:ext cx="1601470" cy="0"/>
              </a:xfrm>
              <a:prstGeom prst="line">
                <a:avLst/>
              </a:prstGeom>
              <a:noFill/>
              <a:ln w="9525">
                <a:solidFill>
                  <a:schemeClr val="dk1">
                    <a:lumMod val="0"/>
                    <a:lumOff val="0"/>
                  </a:schemeClr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</p:cxnSp>
          <p:sp>
            <p:nvSpPr>
              <p:cNvPr id="35" name="Text Box 17">
                <a:extLst>
                  <a:ext uri="{FF2B5EF4-FFF2-40B4-BE49-F238E27FC236}">
                    <a16:creationId xmlns:a16="http://schemas.microsoft.com/office/drawing/2014/main" id="{779216DD-4604-4B00-A1C6-F23D718A132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05100" y="3067215"/>
                <a:ext cx="2195830" cy="295275"/>
              </a:xfrm>
              <a:prstGeom prst="rect">
                <a:avLst/>
              </a:prstGeom>
              <a:noFill/>
              <a:ln w="9525" algn="in">
                <a:solidFill>
                  <a:schemeClr val="dk1">
                    <a:lumMod val="0"/>
                    <a:lumOff val="0"/>
                  </a:schemeClr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CCCCCC"/>
                      </a:outerShdw>
                    </a:effectLst>
                  </a14:hiddenEffects>
                </a:ext>
              </a:extLst>
            </p:spPr>
            <p:txBody>
              <a:bodyPr rot="0" vert="horz" wrap="square" lIns="36576" tIns="36576" rIns="36576" bIns="36576" anchor="t" anchorCtr="0" upright="1"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635</a:t>
                </a: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unconfirmed ARDS</a:t>
                </a:r>
              </a:p>
              <a:p>
                <a:pPr algn="ctr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IE" sz="16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 </a:t>
                </a:r>
              </a:p>
            </p:txBody>
          </p:sp>
        </p:grpSp>
      </p:grpSp>
      <p:cxnSp>
        <p:nvCxnSpPr>
          <p:cNvPr id="37" name="Line 7">
            <a:extLst>
              <a:ext uri="{FF2B5EF4-FFF2-40B4-BE49-F238E27FC236}">
                <a16:creationId xmlns:a16="http://schemas.microsoft.com/office/drawing/2014/main" id="{853F5B70-C68F-4DC8-B3B2-620114771DF1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4332023" y="3316883"/>
            <a:ext cx="0" cy="316939"/>
          </a:xfrm>
          <a:prstGeom prst="line">
            <a:avLst/>
          </a:prstGeom>
          <a:noFill/>
          <a:ln w="9525">
            <a:solidFill>
              <a:schemeClr val="dk1">
                <a:lumMod val="0"/>
                <a:lumOff val="0"/>
              </a:schemeClr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cxnSp>
        <p:nvCxnSpPr>
          <p:cNvPr id="38" name="Line 7">
            <a:extLst>
              <a:ext uri="{FF2B5EF4-FFF2-40B4-BE49-F238E27FC236}">
                <a16:creationId xmlns:a16="http://schemas.microsoft.com/office/drawing/2014/main" id="{853F5B70-C68F-4DC8-B3B2-620114771DF1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4366411" y="4620512"/>
            <a:ext cx="0" cy="316939"/>
          </a:xfrm>
          <a:prstGeom prst="line">
            <a:avLst/>
          </a:prstGeom>
          <a:noFill/>
          <a:ln w="9525">
            <a:solidFill>
              <a:schemeClr val="dk1">
                <a:lumMod val="0"/>
                <a:lumOff val="0"/>
              </a:schemeClr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cxnSp>
        <p:nvCxnSpPr>
          <p:cNvPr id="39" name="Line 7">
            <a:extLst>
              <a:ext uri="{FF2B5EF4-FFF2-40B4-BE49-F238E27FC236}">
                <a16:creationId xmlns:a16="http://schemas.microsoft.com/office/drawing/2014/main" id="{853F5B70-C68F-4DC8-B3B2-620114771DF1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4332023" y="3942423"/>
            <a:ext cx="0" cy="316939"/>
          </a:xfrm>
          <a:prstGeom prst="line">
            <a:avLst/>
          </a:prstGeom>
          <a:noFill/>
          <a:ln w="9525">
            <a:solidFill>
              <a:schemeClr val="dk1">
                <a:lumMod val="0"/>
                <a:lumOff val="0"/>
              </a:schemeClr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</p:spTree>
    <p:extLst>
      <p:ext uri="{BB962C8B-B14F-4D97-AF65-F5344CB8AC3E}">
        <p14:creationId xmlns:p14="http://schemas.microsoft.com/office/powerpoint/2010/main" val="10819024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3">
            <a:extLst>
              <a:ext uri="{FF2B5EF4-FFF2-40B4-BE49-F238E27FC236}">
                <a16:creationId xmlns:a16="http://schemas.microsoft.com/office/drawing/2014/main" id="{FA818C7B-1C05-4947-B5B2-124346AF2DAD}"/>
              </a:ext>
            </a:extLst>
          </p:cNvPr>
          <p:cNvSpPr txBox="1">
            <a:spLocks/>
          </p:cNvSpPr>
          <p:nvPr/>
        </p:nvSpPr>
        <p:spPr>
          <a:xfrm>
            <a:off x="228600" y="153460"/>
            <a:ext cx="2206146" cy="7609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IE" dirty="0"/>
              <a:t>Figure e3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5593" y="228593"/>
            <a:ext cx="6400813" cy="64008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89700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3">
            <a:extLst>
              <a:ext uri="{FF2B5EF4-FFF2-40B4-BE49-F238E27FC236}">
                <a16:creationId xmlns:a16="http://schemas.microsoft.com/office/drawing/2014/main" id="{85C5B75E-284F-4BB2-B361-80FD5EE8B826}"/>
              </a:ext>
            </a:extLst>
          </p:cNvPr>
          <p:cNvSpPr txBox="1">
            <a:spLocks/>
          </p:cNvSpPr>
          <p:nvPr/>
        </p:nvSpPr>
        <p:spPr>
          <a:xfrm>
            <a:off x="228600" y="153460"/>
            <a:ext cx="2206146" cy="7609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IE" dirty="0"/>
              <a:t>Figure e4 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5593" y="228593"/>
            <a:ext cx="6400813" cy="64008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99743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3">
            <a:extLst>
              <a:ext uri="{FF2B5EF4-FFF2-40B4-BE49-F238E27FC236}">
                <a16:creationId xmlns:a16="http://schemas.microsoft.com/office/drawing/2014/main" id="{5EC6CFAD-AC06-4997-882A-F461AFA2DC49}"/>
              </a:ext>
            </a:extLst>
          </p:cNvPr>
          <p:cNvSpPr txBox="1">
            <a:spLocks/>
          </p:cNvSpPr>
          <p:nvPr/>
        </p:nvSpPr>
        <p:spPr>
          <a:xfrm>
            <a:off x="228600" y="153460"/>
            <a:ext cx="2206146" cy="7609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IE" dirty="0"/>
              <a:t>Figure e5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5593" y="1142995"/>
            <a:ext cx="6400813" cy="45720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67913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3">
            <a:extLst>
              <a:ext uri="{FF2B5EF4-FFF2-40B4-BE49-F238E27FC236}">
                <a16:creationId xmlns:a16="http://schemas.microsoft.com/office/drawing/2014/main" id="{5EC6CFAD-AC06-4997-882A-F461AFA2DC49}"/>
              </a:ext>
            </a:extLst>
          </p:cNvPr>
          <p:cNvSpPr txBox="1">
            <a:spLocks/>
          </p:cNvSpPr>
          <p:nvPr/>
        </p:nvSpPr>
        <p:spPr>
          <a:xfrm>
            <a:off x="228600" y="153460"/>
            <a:ext cx="2206146" cy="7609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IE" dirty="0"/>
              <a:t>Figure e6 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5593" y="1142995"/>
            <a:ext cx="6400813" cy="457200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5689" y="1142995"/>
            <a:ext cx="3329422" cy="3008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11613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3">
            <a:extLst>
              <a:ext uri="{FF2B5EF4-FFF2-40B4-BE49-F238E27FC236}">
                <a16:creationId xmlns:a16="http://schemas.microsoft.com/office/drawing/2014/main" id="{85C5B75E-284F-4BB2-B361-80FD5EE8B826}"/>
              </a:ext>
            </a:extLst>
          </p:cNvPr>
          <p:cNvSpPr txBox="1">
            <a:spLocks/>
          </p:cNvSpPr>
          <p:nvPr/>
        </p:nvSpPr>
        <p:spPr>
          <a:xfrm>
            <a:off x="228600" y="153460"/>
            <a:ext cx="2206146" cy="7609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IE" dirty="0"/>
              <a:t>Figure e7 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5576" y="1142983"/>
            <a:ext cx="6400847" cy="45720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41768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3">
            <a:extLst>
              <a:ext uri="{FF2B5EF4-FFF2-40B4-BE49-F238E27FC236}">
                <a16:creationId xmlns:a16="http://schemas.microsoft.com/office/drawing/2014/main" id="{5EC6CFAD-AC06-4997-882A-F461AFA2DC49}"/>
              </a:ext>
            </a:extLst>
          </p:cNvPr>
          <p:cNvSpPr txBox="1">
            <a:spLocks/>
          </p:cNvSpPr>
          <p:nvPr/>
        </p:nvSpPr>
        <p:spPr>
          <a:xfrm>
            <a:off x="228600" y="153460"/>
            <a:ext cx="2206146" cy="7609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IE" dirty="0"/>
              <a:t>Figure e8 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5593" y="1142995"/>
            <a:ext cx="6400813" cy="45720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78511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312</Words>
  <Application>Microsoft Office PowerPoint</Application>
  <PresentationFormat>Widescreen</PresentationFormat>
  <Paragraphs>63</Paragraphs>
  <Slides>10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Supplementary figures E1-E9</vt:lpstr>
      <vt:lpstr>Figure e1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S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cNicholas, Bairbre, UCHG</dc:creator>
  <cp:lastModifiedBy>McNicholas, Bairbre, UCHG</cp:lastModifiedBy>
  <cp:revision>3</cp:revision>
  <dcterms:created xsi:type="dcterms:W3CDTF">2022-11-19T10:12:09Z</dcterms:created>
  <dcterms:modified xsi:type="dcterms:W3CDTF">2022-11-23T12:15:50Z</dcterms:modified>
</cp:coreProperties>
</file>